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19936B-FEE8-41F5-A386-694E8C98A45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3C71BB-4ADE-4CB3-917B-32E0DA02064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E27B35-61BF-4BEA-8922-CE55C9E0B29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4F64C8-B8AD-4398-8B23-09837B215BB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AE0BA0-DAB5-469E-A882-AE2F4595AB0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5F47AD-42DA-4939-A6EA-242D390E07C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30CFCB-835D-4F51-9B83-5B8EE42E668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63699B-55A8-44D9-AD9C-4589BB3254E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4C4866-503F-46C2-A769-F2287F53095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606EA1-F007-434E-9DC1-18C4194B78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27A2B7-F5FC-4FE8-9B23-CC8FD81F56E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70D2AC-6CD7-4D8B-A618-C7DF22CBB94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2DB9161-8AA3-45EB-A9FC-43302C1DDFB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5"/>
          <p:cNvSpPr/>
          <p:nvPr/>
        </p:nvSpPr>
        <p:spPr>
          <a:xfrm>
            <a:off x="230400" y="1080720"/>
            <a:ext cx="37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7"/>
          <p:cNvSpPr/>
          <p:nvPr/>
        </p:nvSpPr>
        <p:spPr>
          <a:xfrm>
            <a:off x="0" y="305748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9"/>
          <p:cNvSpPr/>
          <p:nvPr/>
        </p:nvSpPr>
        <p:spPr>
          <a:xfrm>
            <a:off x="0" y="319572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4" name="Object 8"/>
          <p:cNvGraphicFramePr/>
          <p:nvPr/>
        </p:nvGraphicFramePr>
        <p:xfrm>
          <a:off x="76320" y="1066680"/>
          <a:ext cx="5933880" cy="27529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5" name="Object 8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76320" y="1066680"/>
                    <a:ext cx="5933880" cy="2752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6" name=""/>
          <p:cNvGraphicFramePr/>
          <p:nvPr/>
        </p:nvGraphicFramePr>
        <p:xfrm>
          <a:off x="1220760" y="4602240"/>
          <a:ext cx="4570560" cy="1722240"/>
        </p:xfrm>
        <a:graphic>
          <a:graphicData uri="http://schemas.openxmlformats.org/drawingml/2006/table">
            <a:tbl>
              <a:tblPr/>
              <a:tblGrid>
                <a:gridCol w="1284480"/>
                <a:gridCol w="1036440"/>
                <a:gridCol w="1035000"/>
                <a:gridCol w="1214640"/>
              </a:tblGrid>
              <a:tr h="42876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 gridSpan="3"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                     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ell Viability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          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[percent of untreated cells]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6136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siRN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siRNA alon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RAIL alon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siRNA + TRAIL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136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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M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ontrol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1.1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136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125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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M s145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0.8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8.3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4.9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136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25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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M s145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79.7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1.7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2.3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136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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M s145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8.7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6.5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9.8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7" name="Rectangle 141"/>
          <p:cNvSpPr/>
          <p:nvPr/>
        </p:nvSpPr>
        <p:spPr>
          <a:xfrm>
            <a:off x="263520" y="3976200"/>
            <a:ext cx="498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B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. 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8" name=""/>
          <p:cNvGraphicFramePr/>
          <p:nvPr/>
        </p:nvGraphicFramePr>
        <p:xfrm>
          <a:off x="914400" y="6934320"/>
          <a:ext cx="4648320" cy="1630080"/>
        </p:xfrm>
        <a:graphic>
          <a:graphicData uri="http://schemas.openxmlformats.org/drawingml/2006/table">
            <a:tbl>
              <a:tblPr/>
              <a:tblGrid>
                <a:gridCol w="2779560"/>
                <a:gridCol w="1868760"/>
              </a:tblGrid>
              <a:tr h="5961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siRN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XIAP Protein Levels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[Percent of Untreated Control]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13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.0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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M neg co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16.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13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.0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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M XIAP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5.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13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250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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M XIAP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4.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13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125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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M XIAP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6.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9" name="Rectangle 233"/>
          <p:cNvSpPr/>
          <p:nvPr/>
        </p:nvSpPr>
        <p:spPr>
          <a:xfrm>
            <a:off x="267840" y="6795720"/>
            <a:ext cx="496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C. 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4-22T17:57:31Z</dcterms:created>
  <dc:creator>Jeff</dc:creator>
  <dc:description/>
  <dc:language>en-US</dc:language>
  <cp:lastModifiedBy>Jeff Hager</cp:lastModifiedBy>
  <dcterms:modified xsi:type="dcterms:W3CDTF">2010-01-21T19:51:43Z</dcterms:modified>
  <cp:revision>22</cp:revision>
  <dc:subject/>
  <dc:title>Slide 1</dc:title>
</cp:coreProperties>
</file>